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83" autoAdjust="0"/>
    <p:restoredTop sz="94660"/>
  </p:normalViewPr>
  <p:slideViewPr>
    <p:cSldViewPr snapToGrid="0">
      <p:cViewPr varScale="1">
        <p:scale>
          <a:sx n="56" d="100"/>
          <a:sy n="56" d="100"/>
        </p:scale>
        <p:origin x="58" y="50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A3CE89-865F-4D3C-A302-05A9B0F18C04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189969-5AF9-4EF5-A09C-05BE22CD70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2464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8A0ED1-CEB1-486D-81BD-76AF8F3A0C8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1247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799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171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387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53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542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05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883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92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691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08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06C1F1-C315-4FD1-B133-0AE205DE01D8}" type="datetimeFigureOut">
              <a:rPr lang="en-US" smtClean="0"/>
              <a:t>3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F97E3-1441-49C9-B9FF-02A930B5F4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727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image" Target="../media/image5.tif"/><Relationship Id="rId7" Type="http://schemas.openxmlformats.org/officeDocument/2006/relationships/image" Target="../media/image9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microsoft.com/office/2007/relationships/hdphoto" Target="../media/hdphoto4.wdp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23193" y="1448196"/>
          <a:ext cx="3830637" cy="2568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7" r:id="rId3" imgW="3830511" imgH="2569275" progId="Prism7.Document">
                  <p:embed/>
                </p:oleObj>
              </mc:Choice>
              <mc:Fallback>
                <p:oleObj name="Prism 7" r:id="rId3" imgW="3830511" imgH="2569275" progId="Prism7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3193" y="1448196"/>
                        <a:ext cx="3830637" cy="2568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8298" y="2035496"/>
            <a:ext cx="492443" cy="99963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Colonie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472497" y="2804296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****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3574572" y="1448195"/>
          <a:ext cx="3830637" cy="2568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7" r:id="rId5" imgW="3830511" imgH="2569275" progId="Prism7.Document">
                  <p:embed/>
                </p:oleObj>
              </mc:Choice>
              <mc:Fallback>
                <p:oleObj name="Prism 7" r:id="rId5" imgW="3830511" imgH="2569275" progId="Prism7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74572" y="1448195"/>
                        <a:ext cx="3830637" cy="2568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921484" y="957375"/>
            <a:ext cx="2512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H2461 – BAP1 mutan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53830" y="1010856"/>
            <a:ext cx="2512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H2731 – BAP1 mutan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723876" y="2645276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23193" y="349548"/>
            <a:ext cx="78889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upplemental Fig</a:t>
            </a:r>
            <a:r>
              <a:rPr lang="en-US" sz="2000" b="1" dirty="0"/>
              <a:t>. S1- Clonal survival of MPM cells </a:t>
            </a:r>
            <a:r>
              <a:rPr lang="en-US" sz="2000" b="1" dirty="0" smtClean="0"/>
              <a:t>with</a:t>
            </a:r>
            <a:r>
              <a:rPr lang="en-US" sz="2000" b="1" dirty="0" smtClean="0"/>
              <a:t> </a:t>
            </a:r>
            <a:r>
              <a:rPr lang="en-US" sz="2000" b="1" dirty="0"/>
              <a:t>PARP1 inhibition</a:t>
            </a:r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6952309" y="1409264"/>
          <a:ext cx="3830637" cy="2568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7" r:id="rId7" imgW="3830511" imgH="2569275" progId="Prism7.Document">
                  <p:embed/>
                </p:oleObj>
              </mc:Choice>
              <mc:Fallback>
                <p:oleObj name="Prism 7" r:id="rId7" imgW="3830511" imgH="2569275" progId="Prism7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52309" y="1409264"/>
                        <a:ext cx="3830637" cy="2568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9187922" y="2914036"/>
            <a:ext cx="5693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602686" y="1001001"/>
            <a:ext cx="19598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H290 – WT BAP1</a:t>
            </a:r>
          </a:p>
        </p:txBody>
      </p:sp>
      <p:graphicFrame>
        <p:nvGraphicFramePr>
          <p:cNvPr id="24" name="Object 23"/>
          <p:cNvGraphicFramePr>
            <a:graphicFrameLocks noChangeAspect="1"/>
          </p:cNvGraphicFramePr>
          <p:nvPr>
            <p:extLst/>
          </p:nvPr>
        </p:nvGraphicFramePr>
        <p:xfrm>
          <a:off x="396408" y="4254402"/>
          <a:ext cx="3830637" cy="2568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7" r:id="rId9" imgW="3830511" imgH="2569275" progId="Prism7.Document">
                  <p:embed/>
                </p:oleObj>
              </mc:Choice>
              <mc:Fallback>
                <p:oleObj name="Prism 7" r:id="rId9" imgW="3830511" imgH="2569275" progId="Prism7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6408" y="4254402"/>
                        <a:ext cx="3830637" cy="2568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1042619" y="3966359"/>
            <a:ext cx="19598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H290 – WT BAP1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-3286" y="4802459"/>
            <a:ext cx="492443" cy="99963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2000" b="1" dirty="0">
                <a:cs typeface="Arial" panose="020B0604020202020204" pitchFamily="34" charset="0"/>
              </a:rPr>
              <a:t>Colonies</a:t>
            </a:r>
          </a:p>
        </p:txBody>
      </p:sp>
    </p:spTree>
    <p:extLst>
      <p:ext uri="{BB962C8B-B14F-4D97-AF65-F5344CB8AC3E}">
        <p14:creationId xmlns:p14="http://schemas.microsoft.com/office/powerpoint/2010/main" val="1934773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7789" y="1334262"/>
            <a:ext cx="2575249" cy="218064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6514" y="1334262"/>
            <a:ext cx="2400559" cy="218064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0549" y="1334262"/>
            <a:ext cx="2475204" cy="218064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649769" y="962209"/>
            <a:ext cx="7012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API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599057" y="964930"/>
            <a:ext cx="8762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Merg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34222" y="962209"/>
            <a:ext cx="8931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γH2AX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365753" y="1977139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MSO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7957" y="3886042"/>
            <a:ext cx="2575249" cy="219269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0549" y="3886042"/>
            <a:ext cx="2475204" cy="2192694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326" y="3886042"/>
            <a:ext cx="2400559" cy="2192694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9299464" y="4980820"/>
            <a:ext cx="118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Nirapari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89231" y="252578"/>
            <a:ext cx="111090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. S2- </a:t>
            </a:r>
            <a:r>
              <a:rPr lang="en-US" sz="2000" b="1" dirty="0" err="1"/>
              <a:t>Niraparib</a:t>
            </a:r>
            <a:r>
              <a:rPr lang="en-US" sz="2000" b="1" dirty="0"/>
              <a:t> treatment results in replication fork collapse </a:t>
            </a:r>
            <a:r>
              <a:rPr lang="en-US" sz="2000" b="1" dirty="0" smtClean="0"/>
              <a:t>in </a:t>
            </a:r>
            <a:r>
              <a:rPr lang="en-US" sz="2000" b="1" dirty="0"/>
              <a:t>BAP1-mutant mesothelioma cell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660696" y="6265203"/>
            <a:ext cx="45318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onfocal </a:t>
            </a:r>
            <a:r>
              <a:rPr lang="en-US" sz="2000" b="1" dirty="0" err="1"/>
              <a:t>Immunofluorescent</a:t>
            </a:r>
            <a:r>
              <a:rPr lang="en-US" sz="2000" b="1" dirty="0"/>
              <a:t> microscopy</a:t>
            </a:r>
          </a:p>
        </p:txBody>
      </p:sp>
    </p:spTree>
    <p:extLst>
      <p:ext uri="{BB962C8B-B14F-4D97-AF65-F5344CB8AC3E}">
        <p14:creationId xmlns:p14="http://schemas.microsoft.com/office/powerpoint/2010/main" val="2214450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764874" y="78482"/>
            <a:ext cx="100643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Fig. S3- </a:t>
            </a:r>
            <a:r>
              <a:rPr lang="en-US" sz="2000" b="1" dirty="0" err="1"/>
              <a:t>Niraparib</a:t>
            </a:r>
            <a:r>
              <a:rPr lang="en-US" sz="2000" b="1" dirty="0"/>
              <a:t> treatment results in genomic instability in BAP1 mutant mesothelioma cells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4026720" y="3562959"/>
            <a:ext cx="3917335" cy="3295041"/>
            <a:chOff x="566174" y="1471244"/>
            <a:chExt cx="4753077" cy="4183097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6174" y="1471244"/>
              <a:ext cx="4753077" cy="4183097"/>
            </a:xfrm>
            <a:prstGeom prst="rect">
              <a:avLst/>
            </a:prstGeom>
          </p:spPr>
        </p:pic>
        <p:cxnSp>
          <p:nvCxnSpPr>
            <p:cNvPr id="23" name="Straight Arrow Connector 22"/>
            <p:cNvCxnSpPr/>
            <p:nvPr/>
          </p:nvCxnSpPr>
          <p:spPr>
            <a:xfrm flipH="1">
              <a:off x="2901363" y="2521028"/>
              <a:ext cx="415822" cy="182857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 flipH="1">
              <a:off x="3601734" y="3029541"/>
              <a:ext cx="415822" cy="182857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 flipH="1">
              <a:off x="3855092" y="5136408"/>
              <a:ext cx="415822" cy="182857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/>
          <p:cNvGrpSpPr/>
          <p:nvPr/>
        </p:nvGrpSpPr>
        <p:grpSpPr>
          <a:xfrm>
            <a:off x="4026720" y="528591"/>
            <a:ext cx="3917335" cy="2887063"/>
            <a:chOff x="153220" y="430886"/>
            <a:chExt cx="3917335" cy="2887063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220" y="430886"/>
              <a:ext cx="3917335" cy="2887063"/>
            </a:xfrm>
            <a:prstGeom prst="rect">
              <a:avLst/>
            </a:prstGeom>
          </p:spPr>
        </p:pic>
        <p:cxnSp>
          <p:nvCxnSpPr>
            <p:cNvPr id="29" name="Straight Arrow Connector 28"/>
            <p:cNvCxnSpPr/>
            <p:nvPr/>
          </p:nvCxnSpPr>
          <p:spPr>
            <a:xfrm>
              <a:off x="2791261" y="1240845"/>
              <a:ext cx="346785" cy="303611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TextBox 31"/>
          <p:cNvSpPr txBox="1"/>
          <p:nvPr/>
        </p:nvSpPr>
        <p:spPr>
          <a:xfrm>
            <a:off x="8105987" y="1811570"/>
            <a:ext cx="8659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DMSO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105987" y="4605769"/>
            <a:ext cx="11841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err="1"/>
              <a:t>Niraparib</a:t>
            </a:r>
            <a:endParaRPr lang="en-US" sz="2000" b="1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7011546" y="3711912"/>
            <a:ext cx="342707" cy="144037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4619977" y="4245841"/>
            <a:ext cx="342707" cy="144037"/>
          </a:xfrm>
          <a:prstGeom prst="straightConnector1">
            <a:avLst/>
          </a:prstGeom>
          <a:ln w="571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091202" y="1811570"/>
            <a:ext cx="265529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onfocal microscopy of DAPI-stained nuclei</a:t>
            </a:r>
          </a:p>
        </p:txBody>
      </p:sp>
    </p:spTree>
    <p:extLst>
      <p:ext uri="{BB962C8B-B14F-4D97-AF65-F5344CB8AC3E}">
        <p14:creationId xmlns:p14="http://schemas.microsoft.com/office/powerpoint/2010/main" val="34939276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89629" y="926300"/>
            <a:ext cx="3442995" cy="435612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290596" y="5337774"/>
            <a:ext cx="1138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DMSO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4691" r="13282"/>
          <a:stretch/>
        </p:blipFill>
        <p:spPr>
          <a:xfrm>
            <a:off x="5897724" y="926300"/>
            <a:ext cx="3467100" cy="435612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875624" y="5328848"/>
            <a:ext cx="15112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Nirapari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8263" y="188020"/>
            <a:ext cx="102742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. S4- </a:t>
            </a:r>
            <a:r>
              <a:rPr lang="en-US" sz="2000" b="1" dirty="0" err="1"/>
              <a:t>Niraparib</a:t>
            </a:r>
            <a:r>
              <a:rPr lang="en-US" sz="2000" b="1" dirty="0"/>
              <a:t> results in increased sister chromatid exchange in BAP1-mutant mesothelioma</a:t>
            </a:r>
          </a:p>
        </p:txBody>
      </p:sp>
    </p:spTree>
    <p:extLst>
      <p:ext uri="{BB962C8B-B14F-4D97-AF65-F5344CB8AC3E}">
        <p14:creationId xmlns:p14="http://schemas.microsoft.com/office/powerpoint/2010/main" val="1818703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Widescreen</PresentationFormat>
  <Paragraphs>25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Company>University of Florida Academic Health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romas,Robert A</dc:creator>
  <cp:lastModifiedBy>Hromas,Robert A</cp:lastModifiedBy>
  <cp:revision>1</cp:revision>
  <dcterms:created xsi:type="dcterms:W3CDTF">2017-03-10T15:19:25Z</dcterms:created>
  <dcterms:modified xsi:type="dcterms:W3CDTF">2017-03-10T15:19:54Z</dcterms:modified>
</cp:coreProperties>
</file>